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ED131B-8536-4F31-9643-88E5641250F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74FF8-D68F-43AF-B87E-B25EE191A1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3D419-D8A5-48C7-9E43-0487DE1E2E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F5E38-B6C5-4724-8253-6C0AB845F0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120A0-58A7-4DF0-9F7F-3FB67FEC97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D735D-6FCE-4C2D-9515-4A7411DEF1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62E20-7DF6-4170-BF33-23746B9F31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AE0DF-EFE4-41B1-84BD-976934E170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5185D-4605-4A08-A9B5-62378E1DDD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6B0AF-6C53-4734-BFF4-076B52F1E6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AB06E3-7A66-4538-8D6B-A6A7467513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D6E3D-1135-4A61-991B-ED11B16A53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6026E7-45FC-4531-B547-3D77D0260A2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68360" y="476280"/>
          <a:ext cx="8569440" cy="6621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68360" y="476280"/>
                    <a:ext cx="8569440" cy="6621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1911240" y="1413000"/>
            <a:ext cx="21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Control tutor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5006880" y="1413000"/>
            <a:ext cx="265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Intervention tutor grou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 rot="16200000">
            <a:off x="-1611360" y="3403800"/>
            <a:ext cx="4245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mean post-intervention written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 z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-score adjusted fo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pre-intervention written </a:t>
            </a:r>
            <a:r>
              <a:rPr b="0" i="1" lang="en-GB" sz="14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-scor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164360" y="66600"/>
            <a:ext cx="1979640" cy="98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control – minority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control – whit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62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intervention – minority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300" spc="-1" strike="noStrike">
                <a:solidFill>
                  <a:srgbClr val="000000"/>
                </a:solidFill>
                <a:latin typeface="Arial"/>
              </a:rPr>
              <a:t>intervention – white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020000" y="404640"/>
            <a:ext cx="144360" cy="144720"/>
          </a:xfrm>
          <a:prstGeom prst="ellips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020000" y="189000"/>
            <a:ext cx="144360" cy="144360"/>
          </a:xfrm>
          <a:prstGeom prst="ellipse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020000" y="838080"/>
            <a:ext cx="144360" cy="142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020000" y="622440"/>
            <a:ext cx="144360" cy="142560"/>
          </a:xfrm>
          <a:prstGeom prst="rect">
            <a:avLst/>
          </a:prstGeom>
          <a:solidFill>
            <a:srgbClr val="ff0000"/>
          </a:solidFill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4-28T12:32:26Z</dcterms:created>
  <dc:creator>Psychology</dc:creator>
  <dc:description/>
  <dc:language>en-US</dc:language>
  <cp:lastModifiedBy>Katherine Woolf</cp:lastModifiedBy>
  <dcterms:modified xsi:type="dcterms:W3CDTF">2009-04-29T10:56:11Z</dcterms:modified>
  <cp:revision>6</cp:revision>
  <dc:subject/>
  <dc:title>Slide 1</dc:title>
</cp:coreProperties>
</file>